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3FB79"/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6852"/>
    <p:restoredTop sz="94586"/>
  </p:normalViewPr>
  <p:slideViewPr>
    <p:cSldViewPr snapToGrid="0" snapToObjects="1">
      <p:cViewPr varScale="1">
        <p:scale>
          <a:sx n="110" d="100"/>
          <a:sy n="110" d="100"/>
        </p:scale>
        <p:origin x="576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992BE-C2EB-9147-8C9F-3229CC2084F1}" type="datetimeFigureOut">
              <a:rPr lang="en-US" smtClean="0"/>
              <a:t>9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418FA-7E70-2A43-AA63-100A0CA8BA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887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992BE-C2EB-9147-8C9F-3229CC2084F1}" type="datetimeFigureOut">
              <a:rPr lang="en-US" smtClean="0"/>
              <a:t>9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418FA-7E70-2A43-AA63-100A0CA8BA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9493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992BE-C2EB-9147-8C9F-3229CC2084F1}" type="datetimeFigureOut">
              <a:rPr lang="en-US" smtClean="0"/>
              <a:t>9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418FA-7E70-2A43-AA63-100A0CA8BA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83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992BE-C2EB-9147-8C9F-3229CC2084F1}" type="datetimeFigureOut">
              <a:rPr lang="en-US" smtClean="0"/>
              <a:t>9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418FA-7E70-2A43-AA63-100A0CA8BA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873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992BE-C2EB-9147-8C9F-3229CC2084F1}" type="datetimeFigureOut">
              <a:rPr lang="en-US" smtClean="0"/>
              <a:t>9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418FA-7E70-2A43-AA63-100A0CA8BA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029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992BE-C2EB-9147-8C9F-3229CC2084F1}" type="datetimeFigureOut">
              <a:rPr lang="en-US" smtClean="0"/>
              <a:t>9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418FA-7E70-2A43-AA63-100A0CA8BA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162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992BE-C2EB-9147-8C9F-3229CC2084F1}" type="datetimeFigureOut">
              <a:rPr lang="en-US" smtClean="0"/>
              <a:t>9/1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418FA-7E70-2A43-AA63-100A0CA8BA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260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992BE-C2EB-9147-8C9F-3229CC2084F1}" type="datetimeFigureOut">
              <a:rPr lang="en-US" smtClean="0"/>
              <a:t>9/1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418FA-7E70-2A43-AA63-100A0CA8BA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116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992BE-C2EB-9147-8C9F-3229CC2084F1}" type="datetimeFigureOut">
              <a:rPr lang="en-US" smtClean="0"/>
              <a:t>9/1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418FA-7E70-2A43-AA63-100A0CA8BA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02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992BE-C2EB-9147-8C9F-3229CC2084F1}" type="datetimeFigureOut">
              <a:rPr lang="en-US" smtClean="0"/>
              <a:t>9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418FA-7E70-2A43-AA63-100A0CA8BA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981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992BE-C2EB-9147-8C9F-3229CC2084F1}" type="datetimeFigureOut">
              <a:rPr lang="en-US" smtClean="0"/>
              <a:t>9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418FA-7E70-2A43-AA63-100A0CA8BA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9385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8992BE-C2EB-9147-8C9F-3229CC2084F1}" type="datetimeFigureOut">
              <a:rPr lang="en-US" smtClean="0"/>
              <a:t>9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3418FA-7E70-2A43-AA63-100A0CA8BA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771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9" name="Group 88"/>
          <p:cNvGrpSpPr/>
          <p:nvPr/>
        </p:nvGrpSpPr>
        <p:grpSpPr>
          <a:xfrm>
            <a:off x="121253" y="2475772"/>
            <a:ext cx="5976056" cy="786974"/>
            <a:chOff x="252744" y="2545948"/>
            <a:chExt cx="5976056" cy="786974"/>
          </a:xfrm>
        </p:grpSpPr>
        <p:sp>
          <p:nvSpPr>
            <p:cNvPr id="55" name="Pentagon 54"/>
            <p:cNvSpPr/>
            <p:nvPr/>
          </p:nvSpPr>
          <p:spPr>
            <a:xfrm>
              <a:off x="281073" y="2576783"/>
              <a:ext cx="1015250" cy="756139"/>
            </a:xfrm>
            <a:prstGeom prst="homePlate">
              <a:avLst/>
            </a:prstGeom>
            <a:solidFill>
              <a:schemeClr val="accent2">
                <a:lumMod val="20000"/>
                <a:lumOff val="8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52744" y="2694980"/>
              <a:ext cx="7827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MV</a:t>
              </a:r>
            </a:p>
          </p:txBody>
        </p:sp>
        <p:sp>
          <p:nvSpPr>
            <p:cNvPr id="65" name="Rectangle 64"/>
            <p:cNvSpPr/>
            <p:nvPr/>
          </p:nvSpPr>
          <p:spPr>
            <a:xfrm>
              <a:off x="5017624" y="2561015"/>
              <a:ext cx="836850" cy="75613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5068625" y="2684271"/>
              <a:ext cx="78584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mp</a:t>
              </a:r>
              <a:r>
                <a:rPr lang="en-US" sz="2000" b="1" baseline="30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endPara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" name="Group 2"/>
            <p:cNvGrpSpPr/>
            <p:nvPr/>
          </p:nvGrpSpPr>
          <p:grpSpPr>
            <a:xfrm>
              <a:off x="1259601" y="2545948"/>
              <a:ext cx="2486402" cy="756139"/>
              <a:chOff x="3940554" y="3107851"/>
              <a:chExt cx="2676019" cy="756139"/>
            </a:xfrm>
            <a:noFill/>
          </p:grpSpPr>
          <p:sp>
            <p:nvSpPr>
              <p:cNvPr id="57" name="Rectangle 56"/>
              <p:cNvSpPr/>
              <p:nvPr/>
            </p:nvSpPr>
            <p:spPr>
              <a:xfrm>
                <a:off x="4148530" y="3107851"/>
                <a:ext cx="906840" cy="756139"/>
              </a:xfrm>
              <a:prstGeom prst="rect">
                <a:avLst/>
              </a:prstGeom>
              <a:grpFill/>
              <a:ln w="28575">
                <a:solidFill>
                  <a:schemeClr val="tx1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Rectangle 57"/>
              <p:cNvSpPr/>
              <p:nvPr/>
            </p:nvSpPr>
            <p:spPr>
              <a:xfrm>
                <a:off x="5058388" y="3107851"/>
                <a:ext cx="1558185" cy="756139"/>
              </a:xfrm>
              <a:prstGeom prst="rect">
                <a:avLst/>
              </a:prstGeom>
              <a:grpFill/>
              <a:ln w="28575">
                <a:solidFill>
                  <a:schemeClr val="tx1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4272163" y="3246873"/>
                <a:ext cx="688720" cy="400110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g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5534575" y="3231107"/>
                <a:ext cx="581755" cy="400110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l</a:t>
                </a:r>
              </a:p>
            </p:txBody>
          </p:sp>
          <p:cxnSp>
            <p:nvCxnSpPr>
              <p:cNvPr id="71" name="Straight Connector 70"/>
              <p:cNvCxnSpPr/>
              <p:nvPr/>
            </p:nvCxnSpPr>
            <p:spPr>
              <a:xfrm>
                <a:off x="3940554" y="3492717"/>
                <a:ext cx="200416" cy="0"/>
              </a:xfrm>
              <a:prstGeom prst="line">
                <a:avLst/>
              </a:prstGeom>
              <a:grpFill/>
              <a:ln w="762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3" name="Straight Connector 72"/>
            <p:cNvCxnSpPr/>
            <p:nvPr/>
          </p:nvCxnSpPr>
          <p:spPr>
            <a:xfrm>
              <a:off x="3769280" y="2907124"/>
              <a:ext cx="1243336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>
              <a:off x="5872446" y="2914349"/>
              <a:ext cx="356354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8" name="Group 87"/>
          <p:cNvGrpSpPr/>
          <p:nvPr/>
        </p:nvGrpSpPr>
        <p:grpSpPr>
          <a:xfrm>
            <a:off x="80517" y="664927"/>
            <a:ext cx="11857062" cy="776128"/>
            <a:chOff x="250861" y="1453505"/>
            <a:chExt cx="11857062" cy="776128"/>
          </a:xfrm>
        </p:grpSpPr>
        <p:sp>
          <p:nvSpPr>
            <p:cNvPr id="4" name="Rectangle 3"/>
            <p:cNvSpPr/>
            <p:nvPr/>
          </p:nvSpPr>
          <p:spPr>
            <a:xfrm>
              <a:off x="1443911" y="1473494"/>
              <a:ext cx="867294" cy="756139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Pentagon 4"/>
            <p:cNvSpPr/>
            <p:nvPr/>
          </p:nvSpPr>
          <p:spPr>
            <a:xfrm>
              <a:off x="278225" y="1473494"/>
              <a:ext cx="980663" cy="756139"/>
            </a:xfrm>
            <a:prstGeom prst="homePlate">
              <a:avLst/>
            </a:prstGeom>
            <a:solidFill>
              <a:schemeClr val="accent2">
                <a:lumMod val="20000"/>
                <a:lumOff val="8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>
              <a:off x="2494609" y="1473492"/>
              <a:ext cx="1162538" cy="75613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3843803" y="1473492"/>
              <a:ext cx="813879" cy="75613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4844338" y="1473492"/>
              <a:ext cx="1398454" cy="756139"/>
            </a:xfrm>
            <a:prstGeom prst="rect">
              <a:avLst/>
            </a:prstGeom>
            <a:solidFill>
              <a:srgbClr val="92D050"/>
            </a:solidFill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50861" y="1591691"/>
              <a:ext cx="76350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MV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458984" y="1623223"/>
              <a:ext cx="8636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’LTR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544910" y="1644046"/>
              <a:ext cx="114238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i/RRE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848160" y="1657691"/>
              <a:ext cx="81867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AP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818331" y="1644046"/>
              <a:ext cx="13169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MV-GFP</a:t>
              </a: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6458717" y="1473492"/>
              <a:ext cx="2255125" cy="756139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8907301" y="1473492"/>
              <a:ext cx="801854" cy="75613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909780" y="1628280"/>
              <a:ext cx="76350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RE</a:t>
              </a: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9878592" y="1473492"/>
              <a:ext cx="870480" cy="75613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9881779" y="1584222"/>
              <a:ext cx="8636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’LTR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557901" y="1615754"/>
              <a:ext cx="197432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Zeo</a:t>
              </a:r>
              <a:r>
                <a:rPr lang="en-US" sz="2000" b="1" baseline="30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- </a:t>
              </a:r>
              <a:r>
                <a:rPr lang="en-US" sz="2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cZ</a:t>
              </a:r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- Ori</a:t>
              </a:r>
              <a:endParaRPr 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3" name="Straight Connector 22"/>
            <p:cNvCxnSpPr/>
            <p:nvPr/>
          </p:nvCxnSpPr>
          <p:spPr>
            <a:xfrm>
              <a:off x="2311204" y="1858358"/>
              <a:ext cx="179871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3657147" y="1858358"/>
              <a:ext cx="179871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4665618" y="1858358"/>
              <a:ext cx="179871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6249577" y="1858358"/>
              <a:ext cx="179871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8719293" y="1858358"/>
              <a:ext cx="179871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9709156" y="1858358"/>
              <a:ext cx="179871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>
              <a:off x="10744098" y="1831575"/>
              <a:ext cx="220969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Rectangle 81"/>
            <p:cNvSpPr/>
            <p:nvPr/>
          </p:nvSpPr>
          <p:spPr>
            <a:xfrm>
              <a:off x="10965067" y="1453505"/>
              <a:ext cx="800060" cy="75613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11013826" y="1576761"/>
              <a:ext cx="75130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mp</a:t>
              </a:r>
              <a:r>
                <a:rPr lang="en-US" sz="2000" b="1" baseline="30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endPara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4" name="Straight Connector 83"/>
            <p:cNvCxnSpPr/>
            <p:nvPr/>
          </p:nvCxnSpPr>
          <p:spPr>
            <a:xfrm>
              <a:off x="11767235" y="1806839"/>
              <a:ext cx="340688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/>
            <p:cNvCxnSpPr/>
            <p:nvPr/>
          </p:nvCxnSpPr>
          <p:spPr>
            <a:xfrm>
              <a:off x="1258798" y="1850743"/>
              <a:ext cx="171252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9" name="Group 128"/>
          <p:cNvGrpSpPr/>
          <p:nvPr/>
        </p:nvGrpSpPr>
        <p:grpSpPr>
          <a:xfrm>
            <a:off x="136581" y="4245499"/>
            <a:ext cx="5096363" cy="773655"/>
            <a:chOff x="215411" y="4245499"/>
            <a:chExt cx="5096363" cy="773655"/>
          </a:xfrm>
        </p:grpSpPr>
        <p:sp>
          <p:nvSpPr>
            <p:cNvPr id="91" name="Pentagon 90"/>
            <p:cNvSpPr/>
            <p:nvPr/>
          </p:nvSpPr>
          <p:spPr>
            <a:xfrm>
              <a:off x="215411" y="4245501"/>
              <a:ext cx="1015250" cy="756139"/>
            </a:xfrm>
            <a:prstGeom prst="homePlate">
              <a:avLst/>
            </a:prstGeom>
            <a:solidFill>
              <a:schemeClr val="accent4">
                <a:lumMod val="20000"/>
                <a:lumOff val="8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281678" y="4410996"/>
              <a:ext cx="69923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SV</a:t>
              </a:r>
            </a:p>
          </p:txBody>
        </p:sp>
        <p:sp>
          <p:nvSpPr>
            <p:cNvPr id="93" name="Rectangle 92"/>
            <p:cNvSpPr/>
            <p:nvPr/>
          </p:nvSpPr>
          <p:spPr>
            <a:xfrm>
              <a:off x="4100598" y="4245499"/>
              <a:ext cx="836850" cy="75613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4151599" y="4368755"/>
              <a:ext cx="78584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mp</a:t>
              </a:r>
              <a:r>
                <a:rPr lang="en-US" sz="2000" b="1" baseline="30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endPara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Rectangle 98"/>
            <p:cNvSpPr/>
            <p:nvPr/>
          </p:nvSpPr>
          <p:spPr>
            <a:xfrm>
              <a:off x="1671841" y="4263015"/>
              <a:ext cx="1563852" cy="75613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2089725" y="4449335"/>
              <a:ext cx="72808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V</a:t>
              </a:r>
            </a:p>
          </p:txBody>
        </p:sp>
        <p:cxnSp>
          <p:nvCxnSpPr>
            <p:cNvPr id="102" name="Straight Connector 101"/>
            <p:cNvCxnSpPr/>
            <p:nvPr/>
          </p:nvCxnSpPr>
          <p:spPr>
            <a:xfrm>
              <a:off x="1193939" y="4599532"/>
              <a:ext cx="477902" cy="0"/>
            </a:xfrm>
            <a:prstGeom prst="line">
              <a:avLst/>
            </a:prstGeom>
            <a:noFill/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/>
            <p:cNvCxnSpPr/>
            <p:nvPr/>
          </p:nvCxnSpPr>
          <p:spPr>
            <a:xfrm>
              <a:off x="3230638" y="4591608"/>
              <a:ext cx="856517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Connector 96"/>
            <p:cNvCxnSpPr/>
            <p:nvPr/>
          </p:nvCxnSpPr>
          <p:spPr>
            <a:xfrm>
              <a:off x="4955420" y="4598833"/>
              <a:ext cx="356354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8" name="Group 127"/>
          <p:cNvGrpSpPr/>
          <p:nvPr/>
        </p:nvGrpSpPr>
        <p:grpSpPr>
          <a:xfrm>
            <a:off x="92486" y="5901692"/>
            <a:ext cx="5802630" cy="803437"/>
            <a:chOff x="155550" y="5870160"/>
            <a:chExt cx="5802630" cy="803437"/>
          </a:xfrm>
        </p:grpSpPr>
        <p:sp>
          <p:nvSpPr>
            <p:cNvPr id="106" name="Pentagon 105"/>
            <p:cNvSpPr/>
            <p:nvPr/>
          </p:nvSpPr>
          <p:spPr>
            <a:xfrm>
              <a:off x="183879" y="5870160"/>
              <a:ext cx="1015250" cy="756139"/>
            </a:xfrm>
            <a:prstGeom prst="homePlate">
              <a:avLst/>
            </a:prstGeom>
            <a:solidFill>
              <a:schemeClr val="accent2">
                <a:lumMod val="20000"/>
                <a:lumOff val="8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155550" y="5988357"/>
              <a:ext cx="7827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MV</a:t>
              </a:r>
            </a:p>
          </p:txBody>
        </p:sp>
        <p:sp>
          <p:nvSpPr>
            <p:cNvPr id="108" name="Rectangle 107"/>
            <p:cNvSpPr/>
            <p:nvPr/>
          </p:nvSpPr>
          <p:spPr>
            <a:xfrm>
              <a:off x="4747004" y="5917456"/>
              <a:ext cx="836850" cy="75613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4798005" y="6040712"/>
              <a:ext cx="78584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mp</a:t>
              </a:r>
              <a:r>
                <a:rPr lang="en-US" sz="2000" b="1" baseline="30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endPara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1" name="Straight Connector 110"/>
            <p:cNvCxnSpPr/>
            <p:nvPr/>
          </p:nvCxnSpPr>
          <p:spPr>
            <a:xfrm>
              <a:off x="3498660" y="6263565"/>
              <a:ext cx="1243336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/>
            <p:cNvCxnSpPr/>
            <p:nvPr/>
          </p:nvCxnSpPr>
          <p:spPr>
            <a:xfrm>
              <a:off x="5601826" y="6270790"/>
              <a:ext cx="356354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Rectangle 117"/>
            <p:cNvSpPr/>
            <p:nvPr/>
          </p:nvSpPr>
          <p:spPr>
            <a:xfrm>
              <a:off x="1669192" y="5917458"/>
              <a:ext cx="1829468" cy="75613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2118608" y="6072246"/>
              <a:ext cx="96391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SV-G</a:t>
              </a:r>
            </a:p>
          </p:txBody>
        </p:sp>
        <p:cxnSp>
          <p:nvCxnSpPr>
            <p:cNvPr id="120" name="Straight Connector 119"/>
            <p:cNvCxnSpPr/>
            <p:nvPr/>
          </p:nvCxnSpPr>
          <p:spPr>
            <a:xfrm>
              <a:off x="1191290" y="6253975"/>
              <a:ext cx="477902" cy="0"/>
            </a:xfrm>
            <a:prstGeom prst="line">
              <a:avLst/>
            </a:prstGeom>
            <a:noFill/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1" name="TextBox 120"/>
          <p:cNvSpPr txBox="1"/>
          <p:nvPr/>
        </p:nvSpPr>
        <p:spPr>
          <a:xfrm>
            <a:off x="26623" y="49888"/>
            <a:ext cx="208101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ICO</a:t>
            </a:r>
            <a:r>
              <a:rPr lang="en-US" sz="28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ZF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26623" y="1839904"/>
            <a:ext cx="254589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MDL</a:t>
            </a:r>
            <a:r>
              <a:rPr lang="en-US" sz="28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H-IN+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73127" y="3606858"/>
            <a:ext cx="19565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SV</a:t>
            </a:r>
            <a:r>
              <a:rPr lang="en-US" sz="28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EV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44903" y="5299642"/>
            <a:ext cx="242842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MV</a:t>
            </a:r>
            <a:r>
              <a:rPr lang="en-US" sz="28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SV-G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7857124" y="5001638"/>
            <a:ext cx="34957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awings are not to scale</a:t>
            </a:r>
          </a:p>
        </p:txBody>
      </p:sp>
    </p:spTree>
    <p:extLst>
      <p:ext uri="{BB962C8B-B14F-4D97-AF65-F5344CB8AC3E}">
        <p14:creationId xmlns:p14="http://schemas.microsoft.com/office/powerpoint/2010/main" val="5595548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33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B</dc:creator>
  <cp:lastModifiedBy>Hughes, Stephen (NIH/NCI) [E]</cp:lastModifiedBy>
  <cp:revision>18</cp:revision>
  <dcterms:created xsi:type="dcterms:W3CDTF">2016-06-19T20:06:20Z</dcterms:created>
  <dcterms:modified xsi:type="dcterms:W3CDTF">2016-09-19T17:22:13Z</dcterms:modified>
</cp:coreProperties>
</file>